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58" d="100"/>
          <a:sy n="58" d="100"/>
        </p:scale>
        <p:origin x="3106" y="43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119895" cy="11989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EE47C9-3A18-49DF-B270-357C10234015}" type="datetimeFigureOut">
              <a:rPr lang="it-IT" smtClean="0"/>
              <a:t>23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2CB5F-D247-4F12-8452-CAC9AE6510EA}" type="slidenum">
              <a:rPr lang="it-IT" smtClean="0"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26C8101-0A60-4C12-8759-4E95065263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0280"/>
          <a:stretch/>
        </p:blipFill>
        <p:spPr>
          <a:xfrm>
            <a:off x="431625" y="157200"/>
            <a:ext cx="5467215" cy="909307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3B77B0C-40A2-4C46-A900-7F546FE7DE58}"/>
              </a:ext>
            </a:extLst>
          </p:cNvPr>
          <p:cNvSpPr txBox="1"/>
          <p:nvPr/>
        </p:nvSpPr>
        <p:spPr>
          <a:xfrm>
            <a:off x="0" y="9250275"/>
            <a:ext cx="64743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2</a:t>
            </a:r>
            <a:r>
              <a:rPr lang="en-US" sz="1400" dirty="0"/>
              <a:t>: dendrogram showing the results of the RAPD analysis. The red line indicates 90% homology. On the right-hand side are present the pictures of the patterns produced on gel, and the name of the isolate that produced them.</a:t>
            </a:r>
          </a:p>
        </p:txBody>
      </p:sp>
    </p:spTree>
    <p:extLst>
      <p:ext uri="{BB962C8B-B14F-4D97-AF65-F5344CB8AC3E}">
        <p14:creationId xmlns:p14="http://schemas.microsoft.com/office/powerpoint/2010/main" val="11230640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687B61AC85F5E4E8D40EEC5B1171091" ma:contentTypeVersion="8" ma:contentTypeDescription="Create a new document." ma:contentTypeScope="" ma:versionID="9bfd1891e652b4074e14578e5535e03a">
  <xsd:schema xmlns:xsd="http://www.w3.org/2001/XMLSchema" xmlns:xs="http://www.w3.org/2001/XMLSchema" xmlns:p="http://schemas.microsoft.com/office/2006/metadata/properties" xmlns:ns2="5f217c96-5820-4dc0-803f-6a28aad50dd6" targetNamespace="http://schemas.microsoft.com/office/2006/metadata/properties" ma:root="true" ma:fieldsID="aaa1d3f330f38f830b8a4a89f49b09f2" ns2:_="">
    <xsd:import namespace="5f217c96-5820-4dc0-803f-6a28aad50dd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f217c96-5820-4dc0-803f-6a28aad50dd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07593AB-18C5-4D20-A68E-0C6545F99ED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f217c96-5820-4dc0-803f-6a28aad50dd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805CF9E-9B50-4858-8022-476A77C64F6D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2112D361-E61C-458D-B293-280A324B3F0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4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</dc:creator>
  <cp:lastModifiedBy>Alessandro Passera</cp:lastModifiedBy>
  <cp:revision>10</cp:revision>
  <dcterms:created xsi:type="dcterms:W3CDTF">2019-05-07T12:26:46Z</dcterms:created>
  <dcterms:modified xsi:type="dcterms:W3CDTF">2021-11-23T08:26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687B61AC85F5E4E8D40EEC5B1171091</vt:lpwstr>
  </property>
</Properties>
</file>